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796800" cy="99252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49840" y="0"/>
            <a:ext cx="2946240" cy="496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917280" y="744120"/>
            <a:ext cx="4962600" cy="37227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49840" y="9427680"/>
            <a:ext cx="2946240" cy="4971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D251767-DAB9-410D-97B6-2357AFD146E7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PlaceHolder 1"/>
          <p:cNvSpPr>
            <a:spLocks noGrp="1"/>
          </p:cNvSpPr>
          <p:nvPr>
            <p:ph type="sldImg"/>
          </p:nvPr>
        </p:nvSpPr>
        <p:spPr>
          <a:xfrm>
            <a:off x="917640" y="744480"/>
            <a:ext cx="4962600" cy="3722760"/>
          </a:xfrm>
          <a:prstGeom prst="rect">
            <a:avLst/>
          </a:prstGeom>
          <a:ln w="0">
            <a:noFill/>
          </a:ln>
        </p:spPr>
      </p:sp>
      <p:sp>
        <p:nvSpPr>
          <p:cNvPr id="63" name="PlaceHolder 2"/>
          <p:cNvSpPr>
            <a:spLocks noGrp="1"/>
          </p:cNvSpPr>
          <p:nvPr>
            <p:ph type="body"/>
          </p:nvPr>
        </p:nvSpPr>
        <p:spPr>
          <a:xfrm>
            <a:off x="679320" y="4714560"/>
            <a:ext cx="5438880" cy="446724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200" spc="-1" strike="noStrike">
                <a:solidFill>
                  <a:srgbClr val="000000"/>
                </a:solidFill>
                <a:latin typeface="Calibri"/>
              </a:rPr>
              <a:t>Figure E7 Peripheral blood Th17 response according to whether experienced an exacerbation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(a) Peripheral blood Th17 cell frequencies measured by flow cytometry on cryopreserved samples plotted over time and stratified by whether subjects experienced an exacerbation of their asthma defined as a 0.5 point fall in asthma control questionnaire between screening and symptom day 7 (n=16 exacerbated, n=10 did not). Plots show mean ±95% confidence interval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000000"/>
                </a:solidFill>
                <a:latin typeface="Calibri"/>
              </a:rPr>
              <a:t>(b) Plot of areas under the curve for peripheral Th17 response over time, stratified by whether subjects experienced an exacerbation. P=0.2 for unpaired t test.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4" name="Slide Number Placeholder 3"/>
          <p:cNvSpPr/>
          <p:nvPr/>
        </p:nvSpPr>
        <p:spPr>
          <a:xfrm>
            <a:off x="3849840" y="9428040"/>
            <a:ext cx="2946240" cy="497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C440FAD-85C2-4858-8018-4F93A7BB3626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AC13480-3E72-4D05-9F48-FF40EE10B19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4CE086-C6CB-4DE3-BEF6-61A1460B915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528CAC-905D-4CF2-B108-C2A5ACB42AC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6BEE98-7B9A-45DD-9E8A-BA9809A373F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F3FDAD-9CB0-4BB7-94A4-AD8508DEC09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88C499-6079-45C1-8DF3-ABC6A285D3E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E4C681-7924-47F5-B039-CAE2A8BCB22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E48905-7B1F-44D4-8B76-BA087944FB4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1290CD6-BE18-405A-91BC-4D499AA16D8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8C0FB6-397A-4941-89A3-1BBD0F7C6F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63EE21-CC59-4001-A9D8-E06146E8402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8EB27BD-EF0D-48C8-81E4-B1DE95E82E1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C393338-8B91-44D8-B29D-D7351DF90D5E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wmf"/><Relationship Id="rId5" Type="http://schemas.openxmlformats.org/officeDocument/2006/relationships/slideLayout" Target="../slideLayouts/slideLayout1.xml"/><Relationship Id="rId6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" name="Object 1"/>
          <p:cNvGraphicFramePr/>
          <p:nvPr/>
        </p:nvGraphicFramePr>
        <p:xfrm>
          <a:off x="3995640" y="1179360"/>
          <a:ext cx="2748240" cy="195264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9" name="Object 1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995640" y="1179360"/>
                    <a:ext cx="2748240" cy="19526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0" name="Object 2"/>
          <p:cNvGraphicFramePr/>
          <p:nvPr/>
        </p:nvGraphicFramePr>
        <p:xfrm>
          <a:off x="479520" y="903240"/>
          <a:ext cx="3582720" cy="238932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51" name="Object 2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479520" y="903240"/>
                    <a:ext cx="3582720" cy="23893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52" name="Text Box 14"/>
          <p:cNvSpPr/>
          <p:nvPr/>
        </p:nvSpPr>
        <p:spPr>
          <a:xfrm>
            <a:off x="108000" y="258840"/>
            <a:ext cx="338436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A. Dynamics of peripheral Th17 cell frequenci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95"/>
          <p:cNvSpPr/>
          <p:nvPr/>
        </p:nvSpPr>
        <p:spPr>
          <a:xfrm rot="16200000">
            <a:off x="3189960" y="2077920"/>
            <a:ext cx="1467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AUC of Th17 response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96"/>
          <p:cNvSpPr/>
          <p:nvPr/>
        </p:nvSpPr>
        <p:spPr>
          <a:xfrm>
            <a:off x="4433760" y="3090960"/>
            <a:ext cx="90468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N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exacerb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 Box 96"/>
          <p:cNvSpPr/>
          <p:nvPr/>
        </p:nvSpPr>
        <p:spPr>
          <a:xfrm>
            <a:off x="5031360" y="1311120"/>
            <a:ext cx="513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P=0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</a:rPr>
              <a:t>.</a:t>
            </a: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95"/>
          <p:cNvSpPr/>
          <p:nvPr/>
        </p:nvSpPr>
        <p:spPr>
          <a:xfrm rot="16200000">
            <a:off x="-399600" y="1978560"/>
            <a:ext cx="1553760" cy="398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Th17 cell frequency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(% of total CD4+ T cells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 Box 96"/>
          <p:cNvSpPr/>
          <p:nvPr/>
        </p:nvSpPr>
        <p:spPr>
          <a:xfrm>
            <a:off x="893520" y="3214800"/>
            <a:ext cx="1652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Days since first symptom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 Box 96"/>
          <p:cNvSpPr/>
          <p:nvPr/>
        </p:nvSpPr>
        <p:spPr>
          <a:xfrm>
            <a:off x="2435040" y="1116000"/>
            <a:ext cx="891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Exacerbate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 Box 96"/>
          <p:cNvSpPr/>
          <p:nvPr/>
        </p:nvSpPr>
        <p:spPr>
          <a:xfrm>
            <a:off x="2436120" y="1371600"/>
            <a:ext cx="11012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No exacerbatio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 Box 14"/>
          <p:cNvSpPr/>
          <p:nvPr/>
        </p:nvSpPr>
        <p:spPr>
          <a:xfrm>
            <a:off x="3827520" y="236520"/>
            <a:ext cx="3311640" cy="520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Arial"/>
                <a:ea typeface="Arial"/>
              </a:rPr>
              <a:t>B. Areas under curves for Th17 respons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 Box 96"/>
          <p:cNvSpPr/>
          <p:nvPr/>
        </p:nvSpPr>
        <p:spPr>
          <a:xfrm>
            <a:off x="5619600" y="3224160"/>
            <a:ext cx="891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000" spc="-1" strike="noStrike">
                <a:solidFill>
                  <a:srgbClr val="000000"/>
                </a:solidFill>
                <a:latin typeface="Arial"/>
                <a:ea typeface="Arial"/>
              </a:rPr>
              <a:t>Exacerbated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57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8-13T13:19:05Z</dcterms:created>
  <dc:creator>Hinks T.</dc:creator>
  <dc:description/>
  <dc:language>en-US</dc:language>
  <cp:lastModifiedBy>Hinks T.</cp:lastModifiedBy>
  <cp:lastPrinted>2013-09-25T09:00:55Z</cp:lastPrinted>
  <dcterms:modified xsi:type="dcterms:W3CDTF">2015-02-09T14:52:03Z</dcterms:modified>
  <cp:revision>277</cp:revision>
  <dc:subject/>
  <dc:title>PowerPoint Presentation</dc:title>
</cp:coreProperties>
</file>